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43331F52-E9CD-4CA8-9128-57053ED121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:a16="http://schemas.microsoft.com/office/drawing/2014/main" id="{6E59DD88-0918-4069-A235-8FAFA01203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B5B0DCB8-2008-464A-B2FC-A60E058C75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A6FE5B1E-51AF-4D6F-9237-28A25B4DF7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33DB4254-8D50-4D83-99C3-5E72C367E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87148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E313FB25-EF92-4865-B95E-7CFAB69EEB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id="{7B73283C-696F-48C6-B7C7-26EF7795BB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F6A80DA2-D808-4DD8-A035-BB641DB560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56AD83F4-7486-450B-99FA-BC6EBFB2F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9BA242D6-03C6-4EF7-85EF-E49A055DC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93369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:a16="http://schemas.microsoft.com/office/drawing/2014/main" id="{9833A9E6-911B-4559-8737-AB9FF74208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id="{70DBCF37-A85C-4582-99F4-684335F9CC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D046E06C-349B-4A4C-B6FF-916B180C6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744F2A4E-5FD9-4FC9-9C4A-B3749604C3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CBAE67A2-7D4D-4506-B3A6-46493EFCE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83336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772AA239-0057-43F5-B8F1-36404D72D6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2CE0B4F5-2C68-4335-8827-AA006B66745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CC90513D-DDA3-43DB-872A-AE56AC03A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15C35697-D77B-44EE-9B53-97A6CD664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E7765C16-FEF8-4E5E-81C5-0D194EBEE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22603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05665045-CE2D-4C94-BFE0-7B43AFCD9B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AD0F3476-CA5E-4B98-B187-3648BBCC57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5E420B64-8680-4B8A-8DBF-66A87E7AE9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8FA50A25-7C3B-4FFE-A42B-851E189153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2A9D5BF5-3AB5-4DAA-BBFC-BC043526F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531502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985F2753-86C8-4471-A8C9-B11275901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EFFBB730-1B60-4C65-9D0C-6C347E62F1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id="{8D306341-7457-4FBE-9DF7-507A22C162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09F5A8ED-514E-422E-BD3F-5150D1652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56B492E9-C473-4F61-AC50-A4B874007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77DBA80D-A902-4A39-90EA-F41CC3032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81000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06A97850-0FC1-4678-952E-16986E5A49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78F62510-3018-4BDB-B077-EDDBC3F3B8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id="{C83F7954-F2CC-4BBD-9BD6-07D2F79E9D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:a16="http://schemas.microsoft.com/office/drawing/2014/main" id="{5AE0ED9C-8DF7-4C34-B46E-149BCBFFBA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:a16="http://schemas.microsoft.com/office/drawing/2014/main" id="{5805D12A-D5D5-4D50-B7FE-285992E500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:a16="http://schemas.microsoft.com/office/drawing/2014/main" id="{EFD2A10D-C414-4195-A146-ECE51CFD7C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:a16="http://schemas.microsoft.com/office/drawing/2014/main" id="{4CB031E5-10B4-40B6-94BE-0DD9E0FEC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:a16="http://schemas.microsoft.com/office/drawing/2014/main" id="{EF8F52A9-B49E-4B07-A19F-440286AC8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83418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5BEE8375-41D0-41EB-A71B-99995DBAF9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:a16="http://schemas.microsoft.com/office/drawing/2014/main" id="{E8D8B76D-5B5C-4D12-BA8F-255F057E66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:a16="http://schemas.microsoft.com/office/drawing/2014/main" id="{72D0F108-CEED-4379-A441-2B3B43C799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:a16="http://schemas.microsoft.com/office/drawing/2014/main" id="{94F8D3DD-75C9-40FD-8437-FC945BCB3B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688546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:a16="http://schemas.microsoft.com/office/drawing/2014/main" id="{C43DFB83-BC02-4D06-A648-50AB0CA7D3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:a16="http://schemas.microsoft.com/office/drawing/2014/main" id="{D3538E41-5E75-4A0E-9091-09FC127BB8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:a16="http://schemas.microsoft.com/office/drawing/2014/main" id="{98350B82-0E50-4115-8090-5C7F2708BF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18683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3FE9A6EE-497D-4601-9F32-6B26A13D94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id="{1AE50DBC-AA28-4927-8ED4-6F931DDD0B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id="{1BE7FE8E-3A0D-4F45-B358-69373129DD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2C6AE679-316E-4129-A148-4CBEC55EC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32A4578F-95F5-4EDD-8CF4-B8FBCA20A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4C799726-C9FB-4C1E-90DC-6702E8864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89639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D0B1C426-751B-42FC-9257-B1C09B327F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:a16="http://schemas.microsoft.com/office/drawing/2014/main" id="{A3D08E63-443E-41BE-A419-4219C62CEF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id="{2EBAB12E-977E-4948-9662-373DECF171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id="{91E172EF-EA69-4931-B7B3-D726B2C41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id="{75CE91C2-C8D7-4701-B5D5-A092E1F3E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id="{83C25B92-4136-4FAA-AF8A-632F17E37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8391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id="{79EFBD8D-3628-4AEB-9D7C-0EDC5B3E02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id="{A300BBD1-B6BE-4AD2-9DF7-E4245288ED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id="{EF5F6507-A8C6-4F26-B650-E7E458A4FA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DFFC3E-2C8C-437B-A705-9A09C7E725B4}" type="datetimeFigureOut">
              <a:rPr lang="ru-RU" smtClean="0"/>
              <a:t>31.01.2021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id="{AA067A1F-6E3F-4D57-A848-81D827792A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id="{A0645406-B4F0-4198-A88A-09CC136A2A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BAB33-6286-451E-A2E8-20A81C43B0DB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9344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Группа 10">
            <a:extLst>
              <a:ext uri="{FF2B5EF4-FFF2-40B4-BE49-F238E27FC236}">
                <a16:creationId xmlns:a16="http://schemas.microsoft.com/office/drawing/2014/main" id="{C8B38439-1A26-489A-8E2F-606902A28E3F}"/>
              </a:ext>
            </a:extLst>
          </p:cNvPr>
          <p:cNvGrpSpPr/>
          <p:nvPr/>
        </p:nvGrpSpPr>
        <p:grpSpPr>
          <a:xfrm>
            <a:off x="1273646" y="644577"/>
            <a:ext cx="8834656" cy="5333301"/>
            <a:chOff x="1273646" y="644577"/>
            <a:chExt cx="8834656" cy="5333301"/>
          </a:xfrm>
        </p:grpSpPr>
        <p:pic>
          <p:nvPicPr>
            <p:cNvPr id="5" name="Рисунок 4">
              <a:extLst>
                <a:ext uri="{FF2B5EF4-FFF2-40B4-BE49-F238E27FC236}">
                  <a16:creationId xmlns:a16="http://schemas.microsoft.com/office/drawing/2014/main" id="{428FDEDC-A456-4B13-9958-08ED9288CCF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73646" y="1866185"/>
              <a:ext cx="4822354" cy="2670279"/>
            </a:xfrm>
            <a:prstGeom prst="rect">
              <a:avLst/>
            </a:prstGeom>
          </p:spPr>
        </p:pic>
        <p:pic>
          <p:nvPicPr>
            <p:cNvPr id="2" name="Рисунок 1">
              <a:extLst>
                <a:ext uri="{FF2B5EF4-FFF2-40B4-BE49-F238E27FC236}">
                  <a16:creationId xmlns:a16="http://schemas.microsoft.com/office/drawing/2014/main" id="{835CA033-415B-4463-AB5C-753BDBB9C06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648376" y="2114142"/>
              <a:ext cx="1295968" cy="2422315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29F48390-AB7E-4606-80B4-932E9A77D5E7}"/>
                </a:ext>
              </a:extLst>
            </p:cNvPr>
            <p:cNvSpPr txBox="1"/>
            <p:nvPr/>
          </p:nvSpPr>
          <p:spPr>
            <a:xfrm>
              <a:off x="1273646" y="644577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ru-RU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7BE58D1-9485-4BA0-96E1-C297EC7F6860}"/>
                </a:ext>
              </a:extLst>
            </p:cNvPr>
            <p:cNvSpPr txBox="1"/>
            <p:nvPr/>
          </p:nvSpPr>
          <p:spPr>
            <a:xfrm>
              <a:off x="7559955" y="644577"/>
              <a:ext cx="3561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ru-RU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A48A4E6-571D-46B3-8B30-83B64937CA2C}"/>
                </a:ext>
              </a:extLst>
            </p:cNvPr>
            <p:cNvSpPr txBox="1"/>
            <p:nvPr/>
          </p:nvSpPr>
          <p:spPr>
            <a:xfrm>
              <a:off x="8944344" y="3852472"/>
              <a:ext cx="4283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S</a:t>
              </a:r>
              <a:endParaRPr lang="ru-RU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7B5FC94-555A-4060-BA7E-93554480D57A}"/>
                </a:ext>
              </a:extLst>
            </p:cNvPr>
            <p:cNvSpPr txBox="1"/>
            <p:nvPr/>
          </p:nvSpPr>
          <p:spPr>
            <a:xfrm>
              <a:off x="8961834" y="2505860"/>
              <a:ext cx="11464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TS1338</a:t>
              </a:r>
              <a:endParaRPr lang="ru-RU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4D687E3-CE24-4B33-92CF-FCB596E61ECC}"/>
                </a:ext>
              </a:extLst>
            </p:cNvPr>
            <p:cNvSpPr txBox="1"/>
            <p:nvPr/>
          </p:nvSpPr>
          <p:spPr>
            <a:xfrm rot="16200000">
              <a:off x="7575650" y="4672392"/>
              <a:ext cx="1441420" cy="11695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meg_MTS1338</a:t>
              </a:r>
            </a:p>
            <a:p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meg_control</a:t>
              </a:r>
              <a:endPara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endParaRPr lang="ru-RU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04B03EC8-49AB-4DE6-8AB6-B5B8E2721F9C}"/>
              </a:ext>
            </a:extLst>
          </p:cNvPr>
          <p:cNvSpPr txBox="1"/>
          <p:nvPr/>
        </p:nvSpPr>
        <p:spPr>
          <a:xfrm>
            <a:off x="927652" y="5091589"/>
            <a:ext cx="60960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Figure S2. (A) Quantification of MTS1338 transcripts in MTS1338-expressing clones in log phase </a:t>
            </a:r>
            <a:r>
              <a:rPr lang="en-US"/>
              <a:t>in culture. </a:t>
            </a:r>
            <a:r>
              <a:rPr lang="en-US" dirty="0"/>
              <a:t>(B) Northern blotting of MTS1338-expressing- and control RNA 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165603611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39</Words>
  <Application>Microsoft Office PowerPoint</Application>
  <PresentationFormat>Широкоэкранный</PresentationFormat>
  <Paragraphs>9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Тема Office</vt:lpstr>
      <vt:lpstr>Презентация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Tatyana</dc:creator>
  <cp:lastModifiedBy>Татьяна Ажикина</cp:lastModifiedBy>
  <cp:revision>4</cp:revision>
  <dcterms:created xsi:type="dcterms:W3CDTF">2020-09-07T07:47:02Z</dcterms:created>
  <dcterms:modified xsi:type="dcterms:W3CDTF">2021-01-31T16:30:15Z</dcterms:modified>
</cp:coreProperties>
</file>